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932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5A04C-3E11-40D2-B202-25E9888D020D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03F55-86A9-4E97-89A1-D8B575FC4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5347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5A04C-3E11-40D2-B202-25E9888D020D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03F55-86A9-4E97-89A1-D8B575FC4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0616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5A04C-3E11-40D2-B202-25E9888D020D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03F55-86A9-4E97-89A1-D8B575FC4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7563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5A04C-3E11-40D2-B202-25E9888D020D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03F55-86A9-4E97-89A1-D8B575FC4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0941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5A04C-3E11-40D2-B202-25E9888D020D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03F55-86A9-4E97-89A1-D8B575FC4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9702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5A04C-3E11-40D2-B202-25E9888D020D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03F55-86A9-4E97-89A1-D8B575FC4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081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5A04C-3E11-40D2-B202-25E9888D020D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03F55-86A9-4E97-89A1-D8B575FC4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6857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5A04C-3E11-40D2-B202-25E9888D020D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03F55-86A9-4E97-89A1-D8B575FC4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5065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5A04C-3E11-40D2-B202-25E9888D020D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03F55-86A9-4E97-89A1-D8B575FC4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0242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5A04C-3E11-40D2-B202-25E9888D020D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03F55-86A9-4E97-89A1-D8B575FC4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2352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5A04C-3E11-40D2-B202-25E9888D020D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03F55-86A9-4E97-89A1-D8B575FC4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39526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E5A04C-3E11-40D2-B202-25E9888D020D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403F55-86A9-4E97-89A1-D8B575FC4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38175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32342" y="1408311"/>
            <a:ext cx="4393177" cy="3323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OPG-For 		</a:t>
            </a:r>
            <a:r>
              <a:rPr lang="en-US" sz="1000" dirty="0" smtClean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5’-GGAAATGCAACACACGACAA-3’</a:t>
            </a:r>
            <a:endParaRPr lang="en-US" sz="1000" dirty="0">
              <a:solidFill>
                <a:prstClr val="black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OPG-Rev 	            </a:t>
            </a:r>
            <a:r>
              <a:rPr lang="en-US" sz="1000" dirty="0" smtClean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5’-TACTTTGGTGCCAGGCAAATT-3’</a:t>
            </a:r>
            <a:endParaRPr lang="en-US" sz="1000" dirty="0">
              <a:solidFill>
                <a:prstClr val="black"/>
              </a:solidFill>
              <a:latin typeface="Courier New" pitchFamily="49" charset="0"/>
              <a:cs typeface="Courier New" pitchFamily="49" charset="0"/>
            </a:endParaRPr>
          </a:p>
          <a:p>
            <a:endParaRPr lang="en-US" sz="1000" dirty="0">
              <a:solidFill>
                <a:prstClr val="black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OC-For 		</a:t>
            </a:r>
            <a:r>
              <a:rPr lang="en-US" sz="1000" dirty="0" smtClean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5’-ACCCAGGCGCTACCTGTAT-3’</a:t>
            </a:r>
            <a:endParaRPr lang="en-US" sz="1000" dirty="0">
              <a:solidFill>
                <a:prstClr val="black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OC-Rev 		</a:t>
            </a:r>
            <a:r>
              <a:rPr lang="en-US" sz="1000" dirty="0" smtClean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5’-AGCAGAGCGACACCCTAGAC-3’</a:t>
            </a:r>
            <a:endParaRPr lang="en-US" sz="1000" dirty="0">
              <a:solidFill>
                <a:prstClr val="black"/>
              </a:solidFill>
              <a:latin typeface="Courier New" pitchFamily="49" charset="0"/>
              <a:cs typeface="Courier New" pitchFamily="49" charset="0"/>
            </a:endParaRPr>
          </a:p>
          <a:p>
            <a:endParaRPr lang="en-US" sz="1000" dirty="0">
              <a:solidFill>
                <a:prstClr val="black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OSX- For		</a:t>
            </a:r>
            <a:r>
              <a:rPr lang="en-US" sz="1000" dirty="0" smtClean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5’-CATCTGCCTGGCTCCTTG-3’</a:t>
            </a:r>
            <a:endParaRPr lang="en-US" sz="1000" dirty="0">
              <a:solidFill>
                <a:prstClr val="black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OSX-Rev		</a:t>
            </a:r>
            <a:r>
              <a:rPr lang="en-US" sz="1000" dirty="0" smtClean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5’-GGGACTGGAGCCATAGTGAA-3’</a:t>
            </a:r>
            <a:endParaRPr lang="en-US" sz="1000" dirty="0">
              <a:solidFill>
                <a:prstClr val="black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		</a:t>
            </a:r>
          </a:p>
          <a:p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TGF</a:t>
            </a:r>
            <a:r>
              <a:rPr lang="el-GR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β1</a:t>
            </a:r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-For</a:t>
            </a:r>
            <a:r>
              <a:rPr lang="el-GR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		</a:t>
            </a:r>
            <a:r>
              <a:rPr lang="en-US" sz="1000" dirty="0" smtClean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5’-TGTGACAGCAGGGATAACACA-3’</a:t>
            </a:r>
            <a:endParaRPr lang="en-US" sz="1000" dirty="0">
              <a:solidFill>
                <a:prstClr val="black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TGF</a:t>
            </a:r>
            <a:r>
              <a:rPr lang="el-GR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β1</a:t>
            </a:r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-Rev		</a:t>
            </a:r>
            <a:r>
              <a:rPr lang="en-US" sz="1000" dirty="0" smtClean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5’-GGTCCTTGCGGAAGTCAAT-3’ </a:t>
            </a:r>
            <a:endParaRPr lang="en-US" sz="1000" dirty="0">
              <a:solidFill>
                <a:prstClr val="black"/>
              </a:solidFill>
              <a:latin typeface="Courier New" pitchFamily="49" charset="0"/>
              <a:cs typeface="Courier New" pitchFamily="49" charset="0"/>
            </a:endParaRPr>
          </a:p>
          <a:p>
            <a:endParaRPr lang="en-US" sz="1000" dirty="0">
              <a:solidFill>
                <a:prstClr val="black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TGF</a:t>
            </a:r>
            <a:r>
              <a:rPr lang="el-GR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β</a:t>
            </a:r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-RII-For            </a:t>
            </a:r>
            <a:r>
              <a:rPr lang="en-US" sz="1000" dirty="0" smtClean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5’-CTGCTGCCTGTGTGACTTTG-3’</a:t>
            </a:r>
            <a:endParaRPr lang="en-US" sz="1000" dirty="0">
              <a:solidFill>
                <a:prstClr val="black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TGF</a:t>
            </a:r>
            <a:r>
              <a:rPr lang="el-GR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β</a:t>
            </a:r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-RII-Rev	</a:t>
            </a:r>
            <a:r>
              <a:rPr lang="en-US" sz="1000" dirty="0" smtClean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5’-GACATCGGTCTGCTTGAAGG-3’</a:t>
            </a:r>
            <a:endParaRPr lang="en-US" sz="1000" dirty="0">
              <a:solidFill>
                <a:prstClr val="black"/>
              </a:solidFill>
              <a:latin typeface="Courier New" pitchFamily="49" charset="0"/>
              <a:cs typeface="Courier New" pitchFamily="49" charset="0"/>
            </a:endParaRPr>
          </a:p>
          <a:p>
            <a:endParaRPr lang="en-US" sz="1000" dirty="0">
              <a:solidFill>
                <a:prstClr val="black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err="1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Tuftelin</a:t>
            </a:r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-For	</a:t>
            </a:r>
            <a:r>
              <a:rPr lang="en-US" sz="1000" dirty="0" smtClean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5’-GACGGTGCAGGACTTGCT-3’</a:t>
            </a:r>
            <a:endParaRPr lang="en-US" sz="1000" dirty="0">
              <a:solidFill>
                <a:prstClr val="black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err="1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Tuftelin</a:t>
            </a:r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-Rev	</a:t>
            </a:r>
            <a:r>
              <a:rPr lang="en-US" sz="1000" dirty="0" smtClean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5’-CTCTGGTACCGGCTGAGTGT-3’</a:t>
            </a:r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	</a:t>
            </a:r>
          </a:p>
          <a:p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VEGF-B		</a:t>
            </a:r>
            <a:r>
              <a:rPr lang="en-US" sz="1000" dirty="0" smtClean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5’-CGATGGCCTGGAGTGTGT-3’</a:t>
            </a:r>
            <a:endParaRPr lang="en-US" sz="1000" dirty="0">
              <a:solidFill>
                <a:prstClr val="black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VEGF-B</a:t>
            </a:r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		</a:t>
            </a:r>
            <a:r>
              <a:rPr lang="en-US" sz="1000" dirty="0" smtClean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5’-GCTCGGGTACCGGATCAT-3’</a:t>
            </a:r>
            <a:endParaRPr lang="en-US" sz="1000" dirty="0">
              <a:solidFill>
                <a:prstClr val="black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rPr>
              <a:t>				</a:t>
            </a:r>
          </a:p>
        </p:txBody>
      </p:sp>
      <p:cxnSp>
        <p:nvCxnSpPr>
          <p:cNvPr id="6" name="Straight Connector 5"/>
          <p:cNvCxnSpPr/>
          <p:nvPr/>
        </p:nvCxnSpPr>
        <p:spPr>
          <a:xfrm>
            <a:off x="1322792" y="981755"/>
            <a:ext cx="440461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496894" y="666221"/>
            <a:ext cx="40685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upplemental </a:t>
            </a:r>
            <a:r>
              <a:rPr lang="en-US" sz="12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able 2. Primers used for </a:t>
            </a:r>
            <a:r>
              <a:rPr lang="en-US" sz="1200" b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2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-PCR</a:t>
            </a:r>
          </a:p>
        </p:txBody>
      </p:sp>
      <p:cxnSp>
        <p:nvCxnSpPr>
          <p:cNvPr id="9" name="Straight Connector 8"/>
          <p:cNvCxnSpPr/>
          <p:nvPr/>
        </p:nvCxnSpPr>
        <p:spPr>
          <a:xfrm>
            <a:off x="1322792" y="4628722"/>
            <a:ext cx="440461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1311359" y="1352122"/>
            <a:ext cx="440461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/>
          <p:cNvSpPr txBox="1"/>
          <p:nvPr/>
        </p:nvSpPr>
        <p:spPr>
          <a:xfrm>
            <a:off x="1628775" y="1030161"/>
            <a:ext cx="527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Gene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746028" y="1032591"/>
            <a:ext cx="1283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rimer sequence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1532343" y="4682459"/>
            <a:ext cx="4108516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GF</a:t>
            </a:r>
            <a:r>
              <a:rPr lang="el-GR" sz="11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sz="11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, Transforming growth factor beta; TGF</a:t>
            </a:r>
            <a:r>
              <a:rPr lang="el-GR" sz="11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sz="11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-RII, Transforming growth factor beta receptor II; VEGF-B, Vascular endothelial growth factor-B.  </a:t>
            </a:r>
          </a:p>
        </p:txBody>
      </p:sp>
    </p:spTree>
    <p:extLst>
      <p:ext uri="{BB962C8B-B14F-4D97-AF65-F5344CB8AC3E}">
        <p14:creationId xmlns:p14="http://schemas.microsoft.com/office/powerpoint/2010/main" val="83749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38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5</cp:revision>
  <dcterms:created xsi:type="dcterms:W3CDTF">2013-09-27T17:59:05Z</dcterms:created>
  <dcterms:modified xsi:type="dcterms:W3CDTF">2013-09-28T14:37:55Z</dcterms:modified>
</cp:coreProperties>
</file>